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281C0293-94B7-C203-6666-2D99E48276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99EB2938-EDEE-680D-A3AA-9096756811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24806FF-7B3D-24AD-4A52-05300E4F7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B030CD35-B718-6514-F139-0FAB61CD5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67FF1021-D45A-C5F3-6EBA-1AFB7CE73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791597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5F70EBF-C2D1-B709-9267-206FAC8B7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7A886DCD-1114-7042-42BF-B01110C0B4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CE4672D3-5E1B-66A4-76CC-AB109A4AE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0502DF21-CAEE-1B8A-0A06-BDA39E415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43330ABF-A3E9-14F3-B98A-273A3812F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59397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F9238459-00F1-4269-13DF-334E867866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71A51755-BD49-4A60-54C5-1972237BE5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A847A97E-8264-8CB8-AB0F-C3403658C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35DB6702-4E7E-92B5-B1A4-FAFC3048C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1C632F53-9E01-0988-753C-3319122E4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158419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08B04FC-52C4-E17F-D7C2-08BEB8D0E2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352DF6A7-76EB-8143-5196-1D9C6F0A40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C4E59F4-3C36-2117-32BB-810B45F66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DBE4B198-6F57-39DF-1F0F-DAED2B0FA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C7E08A4E-9C97-087D-BD17-3DA34BAF7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49466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9B68FFC-8754-FF2E-EAE1-38944E648E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0E7427D8-CC45-F9B8-5EB4-2C501A3D2B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159FB658-1DC4-B7EE-3521-7349B897A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34AE7ADB-ACE9-0C72-EDA0-629D6E4E9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F3E86786-30C8-36BD-C5EF-1568CB86C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14097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06A38FAD-4C6D-B4AC-D892-54FEE50333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EDAE40DF-1B08-71A9-B084-95E8558F58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87CF3E4B-8BD5-A0EE-B61B-B27D805EDB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99DA847A-F6B0-8B80-5F1A-B5C9330CC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FED92F87-97CE-53FE-E7F2-015B17417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32EE4EFB-35F9-9EFD-C499-2A48D9AAA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336160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DF4E6D7-BC77-FF78-6FB7-B32BDCFCC2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7F769B40-F4FF-BB36-7ABD-9616115B2A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375C0818-E1F4-9C28-469D-286A118654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D77E1193-0C11-3034-7497-D4B8C9A18F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7F94B69C-4572-750A-F6C7-456F31A783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C700E02E-5627-4205-85E5-E92D16DF2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0816ABCB-C524-BEFD-FA1B-F1697071F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84F742BF-5B88-51D9-074D-41AD2D726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72109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45C4FB83-4CAE-C9CD-88D6-E9562D569C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DA1CEA54-99F4-C8CD-3915-9717516F5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7C28431D-FF04-2C0B-9615-3B082F951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97F0BC9C-24E0-0711-7CA7-5B48051F6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42955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6FD2A0D9-DFBE-7401-A677-6EC695DDB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7D6D01FD-4181-63D8-8D63-BAFB14DB4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289F952B-95DC-4B53-783E-9164C5AB6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781389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E2CB3185-17DA-63C6-42DE-1B324F5DB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11D57DA3-259D-40C6-DF3A-4C0DFC1002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F56E1192-7A20-99CE-3CFE-C0BDF25CD7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3F2099C1-BE20-46BF-156B-CE51A54D2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2CA87F42-1152-F76C-A543-F11852021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67F7E3A9-E356-9E4E-F1DF-5444CBC25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37840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8D87FBA4-9199-4B4E-2415-8D97559BB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8C3B76E9-BB23-8ACC-6DD3-CFB51B1B47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286843E5-E836-E178-D147-AB8DB920A3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9FC81108-5118-4C34-1B51-D12FA0959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B87E1B9E-7F05-154F-403D-BB38C0CE2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6510BEFC-62CB-1823-41EB-93F53FCD29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284782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D447F529-F609-EF08-D6FE-F46D87B710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E63D53BF-352D-42C6-E6D7-026E0BA774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AB7C8CE4-A400-0F50-1541-DDF2223BB1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21FA5-1BA6-43FC-B737-AF9E49648F80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95B78E51-1519-67FF-32F6-8A89A96D6D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EE5C7B2D-AAA3-8D21-0901-4B1D789F6C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7555B-B3B4-446A-B562-0EA89730E4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086329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>
            <a:extLst>
              <a:ext uri="{FF2B5EF4-FFF2-40B4-BE49-F238E27FC236}">
                <a16:creationId xmlns:a16="http://schemas.microsoft.com/office/drawing/2014/main" id="{110959F3-1404-BEBC-804B-B52FBE98CB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0897" y="558234"/>
            <a:ext cx="3457632" cy="4009833"/>
          </a:xfrm>
          <a:prstGeom prst="rect">
            <a:avLst/>
          </a:prstGeom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37B7E2F2-46E3-F0BF-BF5E-0069CDB2708B}"/>
              </a:ext>
            </a:extLst>
          </p:cNvPr>
          <p:cNvSpPr txBox="1"/>
          <p:nvPr/>
        </p:nvSpPr>
        <p:spPr>
          <a:xfrm>
            <a:off x="947108" y="4861366"/>
            <a:ext cx="9814704" cy="2802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I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Figure S11: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The analysis of variance (ANOVA) results from the response surface regression for yield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605214423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11:32Z</dcterms:created>
  <dcterms:modified xsi:type="dcterms:W3CDTF">2026-02-22T09:12:33Z</dcterms:modified>
</cp:coreProperties>
</file>